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C2519-1726-4C08-B47F-8BE9121722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33176D-981A-4A1F-BB38-1D81952471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E7EBED-5F6E-476D-9B38-C341DD5343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040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4672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08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040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4672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43A536-1620-45EC-A599-CFA01C18BF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B7E301-D5F2-43F8-A6FD-DA5770FCA4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34FE7-1CC6-4924-B48B-9E012077B7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ED4232-74ED-4C12-A991-43E34E14C2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EB2DF3-4B35-4B36-BCC0-5F119A1C02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080" y="812520"/>
            <a:ext cx="5815080" cy="699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3D471E-97AA-4FC9-9DA4-3F063A5B27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3BE08B-6517-4A9C-8C5B-3DF5AE53A7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75159-ADC5-4C4F-8A5C-DDA53D74AD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2388C-5BD8-4597-94F2-226BA6A086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31120"/>
            <a:ext cx="215748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6E67619A-3FE3-4DD9-9CB4-D7FDA654113B}" type="slidenum">
              <a: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image" Target="../media/image1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79"/>
          <p:cNvGrpSpPr/>
          <p:nvPr/>
        </p:nvGrpSpPr>
        <p:grpSpPr>
          <a:xfrm>
            <a:off x="4365720" y="324000"/>
            <a:ext cx="1800000" cy="1145160"/>
            <a:chOff x="4365720" y="324000"/>
            <a:chExt cx="1800000" cy="1145160"/>
          </a:xfrm>
        </p:grpSpPr>
        <p:sp>
          <p:nvSpPr>
            <p:cNvPr id="42" name="Rectangle 369"/>
            <p:cNvSpPr/>
            <p:nvPr/>
          </p:nvSpPr>
          <p:spPr>
            <a:xfrm>
              <a:off x="4365720" y="324000"/>
              <a:ext cx="1800000" cy="114372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43" name="Rectangle 370"/>
            <p:cNvSpPr/>
            <p:nvPr/>
          </p:nvSpPr>
          <p:spPr>
            <a:xfrm>
              <a:off x="4434480" y="424080"/>
              <a:ext cx="137880" cy="1285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44" name="Rectangle 371"/>
            <p:cNvSpPr/>
            <p:nvPr/>
          </p:nvSpPr>
          <p:spPr>
            <a:xfrm>
              <a:off x="4632840" y="366840"/>
              <a:ext cx="10843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0" lang="nl-NL" sz="1600" spc="-1" strike="noStrike">
                  <a:solidFill>
                    <a:srgbClr val="000000"/>
                  </a:solidFill>
                  <a:latin typeface="Arial"/>
                </a:rPr>
                <a:t>Hypothyroid</a:t>
              </a:r>
              <a:endParaRPr b="0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45" name="Rectangle 372"/>
            <p:cNvSpPr/>
            <p:nvPr/>
          </p:nvSpPr>
          <p:spPr>
            <a:xfrm>
              <a:off x="4434480" y="709920"/>
              <a:ext cx="137880" cy="128520"/>
            </a:xfrm>
            <a:prstGeom prst="rect">
              <a:avLst/>
            </a:prstGeom>
            <a:solidFill>
              <a:srgbClr val="339966"/>
            </a:solidFill>
            <a:ln w="936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46" name="Rectangle 373"/>
            <p:cNvSpPr/>
            <p:nvPr/>
          </p:nvSpPr>
          <p:spPr>
            <a:xfrm>
              <a:off x="4657680" y="652680"/>
              <a:ext cx="104616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sb</a:t>
              </a:r>
              <a:r>
                <a:rPr b="0" i="1" lang="en-US" sz="16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m/m</a:t>
              </a: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Xpa</a:t>
              </a:r>
              <a:r>
                <a:rPr b="0" i="1" lang="en-US" sz="16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-</a:t>
              </a:r>
              <a:endParaRPr b="0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47" name="Rectangle 374"/>
            <p:cNvSpPr/>
            <p:nvPr/>
          </p:nvSpPr>
          <p:spPr>
            <a:xfrm>
              <a:off x="4434480" y="995760"/>
              <a:ext cx="137880" cy="128520"/>
            </a:xfrm>
            <a:prstGeom prst="rect">
              <a:avLst/>
            </a:prstGeom>
            <a:solidFill>
              <a:srgbClr val="ffcc00"/>
            </a:solidFill>
            <a:ln w="9360">
              <a:solidFill>
                <a:srgbClr val="ff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48" name="Rectangle 375"/>
            <p:cNvSpPr/>
            <p:nvPr/>
          </p:nvSpPr>
          <p:spPr>
            <a:xfrm>
              <a:off x="4650480" y="938520"/>
              <a:ext cx="833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Ercc1</a:t>
              </a:r>
              <a:r>
                <a:rPr b="0" i="1" lang="en-US" sz="16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-/Δ-7</a:t>
              </a: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endParaRPr b="0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49" name="Rectangle 376"/>
            <p:cNvSpPr/>
            <p:nvPr/>
          </p:nvSpPr>
          <p:spPr>
            <a:xfrm>
              <a:off x="4434480" y="1281600"/>
              <a:ext cx="137880" cy="1285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0" name="Rectangle 377"/>
            <p:cNvSpPr/>
            <p:nvPr/>
          </p:nvSpPr>
          <p:spPr>
            <a:xfrm>
              <a:off x="4632840" y="1225440"/>
              <a:ext cx="13096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0" lang="nl-NL" sz="1600" spc="-1" strike="noStrike">
                  <a:solidFill>
                    <a:srgbClr val="000000"/>
                  </a:solidFill>
                  <a:latin typeface="Arial"/>
                </a:rPr>
                <a:t>Naturally aged</a:t>
              </a:r>
              <a:endParaRPr b="0" lang="en-US" sz="16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pic>
        <p:nvPicPr>
          <p:cNvPr id="51" name="Picture 380" descr=""/>
          <p:cNvPicPr/>
          <p:nvPr/>
        </p:nvPicPr>
        <p:blipFill>
          <a:blip r:embed="rId1"/>
          <a:srcRect l="0" t="0" r="50197" b="0"/>
          <a:stretch/>
        </p:blipFill>
        <p:spPr>
          <a:xfrm>
            <a:off x="0" y="468360"/>
            <a:ext cx="6093000" cy="5189400"/>
          </a:xfrm>
          <a:prstGeom prst="rect">
            <a:avLst/>
          </a:prstGeom>
          <a:ln w="0">
            <a:noFill/>
          </a:ln>
        </p:spPr>
      </p:pic>
      <p:grpSp>
        <p:nvGrpSpPr>
          <p:cNvPr id="52" name="Group 383"/>
          <p:cNvGrpSpPr/>
          <p:nvPr/>
        </p:nvGrpSpPr>
        <p:grpSpPr>
          <a:xfrm>
            <a:off x="-6480" y="4032360"/>
            <a:ext cx="6624720" cy="5193720"/>
            <a:chOff x="-6480" y="4032360"/>
            <a:chExt cx="6624720" cy="5193720"/>
          </a:xfrm>
        </p:grpSpPr>
        <p:pic>
          <p:nvPicPr>
            <p:cNvPr id="53" name="Picture 381" descr=""/>
            <p:cNvPicPr/>
            <p:nvPr/>
          </p:nvPicPr>
          <p:blipFill>
            <a:blip r:embed="rId2"/>
            <a:srcRect l="0" t="0" r="95926" b="0"/>
            <a:stretch/>
          </p:blipFill>
          <p:spPr>
            <a:xfrm>
              <a:off x="-6480" y="4032360"/>
              <a:ext cx="500040" cy="5189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382" descr=""/>
            <p:cNvPicPr/>
            <p:nvPr/>
          </p:nvPicPr>
          <p:blipFill>
            <a:blip r:embed="rId3"/>
            <a:srcRect l="49975" t="0" r="0" b="0"/>
            <a:stretch/>
          </p:blipFill>
          <p:spPr>
            <a:xfrm>
              <a:off x="498600" y="4036320"/>
              <a:ext cx="6119640" cy="51897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5" name="Text Box 384"/>
          <p:cNvSpPr/>
          <p:nvPr/>
        </p:nvSpPr>
        <p:spPr>
          <a:xfrm>
            <a:off x="0" y="8244000"/>
            <a:ext cx="443700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S2 Fig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Top ranking pathways from differentially expressed genes in liver whole transcriptomes of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Csb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m/m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/Xpa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,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rcc1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Δ-7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, hypothyroid and naturally aged mice compared to their WT controls. Only significant pathways in all four groups are represented.</a:t>
            </a:r>
            <a:endParaRPr b="0" lang="en-US" sz="11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9T09:26:31Z</dcterms:created>
  <dc:creator>USER</dc:creator>
  <dc:description/>
  <dc:language>en-US</dc:language>
  <cp:lastModifiedBy>Edward Visser</cp:lastModifiedBy>
  <dcterms:modified xsi:type="dcterms:W3CDTF">2016-02-11T12:44:35Z</dcterms:modified>
  <cp:revision>111</cp:revision>
  <dc:subject/>
  <dc:title>PowerPoint Presentation</dc:title>
</cp:coreProperties>
</file>